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my Hanna" initials="RH" lastIdx="1" clrIdx="0">
    <p:extLst>
      <p:ext uri="{19B8F6BF-5375-455C-9EA6-DF929625EA0E}">
        <p15:presenceInfo xmlns:p15="http://schemas.microsoft.com/office/powerpoint/2012/main" userId="26b08711a4c1975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0C46CB-5241-4BBE-A558-5EB42ACC98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E651EE3-D0D2-493B-9471-A25AB37DFE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CA4E4F-A9B3-48FC-9AF9-8C1B744A4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24764B-AD0E-43E2-9B4C-62E2409EB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30C03-C95E-4D0A-BDBB-FE300D6BF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732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C3825-62EB-485E-A771-F6BC00032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15F957-FE01-43BD-B47E-55F83876CC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731EEA-4002-47A0-AC50-50F283F29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E6875-B154-4012-AE55-1223B3A35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7506A2-1BC2-4823-9511-13EEF16C5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0656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1BEB87F-C291-4E4D-973B-003FAE4A982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0F50A3-8AE9-475E-AAC4-8CC63B7D8A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337C23-3BB7-45E2-B04D-01FE869B5A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511F90-1536-4A35-96E1-BC66B09625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7D8226-2277-4580-8D02-66F6F8ADB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583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80B24-3307-4DD0-BEBE-89C728026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293BA3-06E9-4B48-A169-845646917F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855B52-FB7D-4537-9D1D-6BA220966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D75F6C-0599-4AC3-8FC8-1B3768FF34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B92466-B5FF-476B-AD92-2B03A3B95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459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BFC66-7AC0-4DB9-8EC5-1FF0E847B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89E147-DEE2-461F-B7A4-341CF780E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2E118-A05F-419A-A89E-1DBC7F051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4D5CDC-1885-40B5-B1CF-3C9A5B327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704B0D-2777-466A-A279-C55A56C47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327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3587B9-9056-4AD7-BE8B-CF8AE83ACB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F29C6A-42CB-48C1-A799-2FF3AD2C3E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0654B4-B05C-4AA4-A795-EF5ECDC03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7BB7D3-ED6A-48DA-B5F6-C70EF1832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C4EA9D-0D2A-4206-A2E1-CB28503F9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80AD0C-73AF-4CDC-87F9-E94864297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152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470255-27C8-4862-A47D-583849507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EB26C0-4B0F-4981-B410-88709ED609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E11C1E-AF53-44BB-9813-D44FD4C5A3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E39A49-10D7-4EAD-ABDB-1AD5B0A680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6EBE6EC-7970-46ED-84EE-19D2020611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444E35-9FE7-4084-BAC7-EEA145AC5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CF7444-A2C5-4A15-82E9-D9B6B69C8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9B8365-E3F7-4012-9222-FD69BBCA3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688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278E1-F54F-49C2-A167-DA4E9CC7D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2A9DF3-8185-48E2-98B5-2704848A0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C6A99A-4DB8-4E56-8770-67D2119F1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BF967B-CF2F-4D7F-974C-90B69E78D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147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BD7ABF-3DF2-4700-9433-9736CA1ED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4EB5DD-D72A-415D-AA61-F152C6CAA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8E18D1-9514-4E49-8791-8294B5217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239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CB575-AC1E-4266-A19D-220AFD202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49F8E0-9703-474B-8603-6BB281811E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E97C9B-768C-4386-81F2-B68BFFF3D7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086A01-BDB0-4D1F-8B45-D1D858B89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91EE2F-8D3D-43EC-9B72-48B1CF30A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1D4E3B-6494-4F23-ACB3-144743553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73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D0924-3887-46A1-8B85-E732543042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E2A127-93A9-41C7-95B4-A458BFC901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A340C4-BF6F-4FA2-846A-DD6B39970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441A4E-F51F-4C5A-B470-2FB585408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2A05A3-7B68-4B76-A568-183812A61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3AD7B4-DFB1-4A33-A293-86337F4D7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412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8143D22-307E-405D-BA5B-EC2902E03D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FB1C51-49B2-4E9A-926E-E016DB131B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32F9DD-3334-4C90-8C7E-35E0A33A05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460B4-70E8-425F-B929-B2202BCA4D7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5A9601-E9CA-42D9-9617-464EC7A032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45DF16-1592-45EA-82C3-AD998EBBF8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7259D-BA16-4739-9290-80D8E58C46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531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9960B1FF-765A-4000-B076-DD82A25F794E}"/>
              </a:ext>
            </a:extLst>
          </p:cNvPr>
          <p:cNvSpPr/>
          <p:nvPr/>
        </p:nvSpPr>
        <p:spPr>
          <a:xfrm>
            <a:off x="6828225" y="1435958"/>
            <a:ext cx="1848395" cy="3705834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hilly" dir="t">
              <a:rot lat="0" lon="0" rev="18480000"/>
            </a:lightRig>
          </a:scene3d>
          <a:sp3d prstMaterial="clear">
            <a:bevelT h="635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7C536538-930B-460F-A2BF-6E832E8332E8}"/>
              </a:ext>
            </a:extLst>
          </p:cNvPr>
          <p:cNvSpPr/>
          <p:nvPr/>
        </p:nvSpPr>
        <p:spPr>
          <a:xfrm>
            <a:off x="8715249" y="853939"/>
            <a:ext cx="811232" cy="381379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A7FB6C12-297F-4ADB-AE9F-81A458F68DFA}"/>
              </a:ext>
            </a:extLst>
          </p:cNvPr>
          <p:cNvSpPr/>
          <p:nvPr/>
        </p:nvSpPr>
        <p:spPr>
          <a:xfrm>
            <a:off x="4098930" y="5607288"/>
            <a:ext cx="478302" cy="503734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4F761126-DE54-47FA-9E1B-486D3FA69F01}"/>
              </a:ext>
            </a:extLst>
          </p:cNvPr>
          <p:cNvSpPr/>
          <p:nvPr/>
        </p:nvSpPr>
        <p:spPr>
          <a:xfrm>
            <a:off x="7919513" y="1804211"/>
            <a:ext cx="744598" cy="55475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6E40113-2E55-4AB3-A762-856D0AB81DE9}"/>
              </a:ext>
            </a:extLst>
          </p:cNvPr>
          <p:cNvSpPr txBox="1"/>
          <p:nvPr/>
        </p:nvSpPr>
        <p:spPr>
          <a:xfrm>
            <a:off x="234892" y="243281"/>
            <a:ext cx="408426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A</a:t>
            </a:r>
          </a:p>
        </p:txBody>
      </p:sp>
      <p:sp>
        <p:nvSpPr>
          <p:cNvPr id="8" name="Freeform: Shape 7">
            <a:extLst>
              <a:ext uri="{FF2B5EF4-FFF2-40B4-BE49-F238E27FC236}">
                <a16:creationId xmlns:a16="http://schemas.microsoft.com/office/drawing/2014/main" id="{15F06DA5-3F32-494F-AF15-4B0F62A33505}"/>
              </a:ext>
            </a:extLst>
          </p:cNvPr>
          <p:cNvSpPr/>
          <p:nvPr/>
        </p:nvSpPr>
        <p:spPr>
          <a:xfrm>
            <a:off x="3643073" y="1435958"/>
            <a:ext cx="802887" cy="3763752"/>
          </a:xfrm>
          <a:custGeom>
            <a:avLst/>
            <a:gdLst>
              <a:gd name="connsiteX0" fmla="*/ 802887 w 802887"/>
              <a:gd name="connsiteY0" fmla="*/ 0 h 1338147"/>
              <a:gd name="connsiteX1" fmla="*/ 802887 w 802887"/>
              <a:gd name="connsiteY1" fmla="*/ 0 h 1338147"/>
              <a:gd name="connsiteX2" fmla="*/ 334536 w 802887"/>
              <a:gd name="connsiteY2" fmla="*/ 22303 h 1338147"/>
              <a:gd name="connsiteX3" fmla="*/ 22302 w 802887"/>
              <a:gd name="connsiteY3" fmla="*/ 44605 h 1338147"/>
              <a:gd name="connsiteX4" fmla="*/ 0 w 802887"/>
              <a:gd name="connsiteY4" fmla="*/ 111513 h 1338147"/>
              <a:gd name="connsiteX5" fmla="*/ 22302 w 802887"/>
              <a:gd name="connsiteY5" fmla="*/ 223025 h 1338147"/>
              <a:gd name="connsiteX6" fmla="*/ 200721 w 802887"/>
              <a:gd name="connsiteY6" fmla="*/ 178420 h 1338147"/>
              <a:gd name="connsiteX7" fmla="*/ 446048 w 802887"/>
              <a:gd name="connsiteY7" fmla="*/ 200722 h 1338147"/>
              <a:gd name="connsiteX8" fmla="*/ 579863 w 802887"/>
              <a:gd name="connsiteY8" fmla="*/ 245327 h 1338147"/>
              <a:gd name="connsiteX9" fmla="*/ 602165 w 802887"/>
              <a:gd name="connsiteY9" fmla="*/ 312235 h 1338147"/>
              <a:gd name="connsiteX10" fmla="*/ 535258 w 802887"/>
              <a:gd name="connsiteY10" fmla="*/ 356839 h 1338147"/>
              <a:gd name="connsiteX11" fmla="*/ 267629 w 802887"/>
              <a:gd name="connsiteY11" fmla="*/ 379142 h 1338147"/>
              <a:gd name="connsiteX12" fmla="*/ 133814 w 802887"/>
              <a:gd name="connsiteY12" fmla="*/ 423747 h 1338147"/>
              <a:gd name="connsiteX13" fmla="*/ 200721 w 802887"/>
              <a:gd name="connsiteY13" fmla="*/ 468352 h 1338147"/>
              <a:gd name="connsiteX14" fmla="*/ 557561 w 802887"/>
              <a:gd name="connsiteY14" fmla="*/ 512957 h 1338147"/>
              <a:gd name="connsiteX15" fmla="*/ 646770 w 802887"/>
              <a:gd name="connsiteY15" fmla="*/ 624469 h 1338147"/>
              <a:gd name="connsiteX16" fmla="*/ 579863 w 802887"/>
              <a:gd name="connsiteY16" fmla="*/ 669074 h 1338147"/>
              <a:gd name="connsiteX17" fmla="*/ 111512 w 802887"/>
              <a:gd name="connsiteY17" fmla="*/ 713678 h 1338147"/>
              <a:gd name="connsiteX18" fmla="*/ 133814 w 802887"/>
              <a:gd name="connsiteY18" fmla="*/ 802888 h 1338147"/>
              <a:gd name="connsiteX19" fmla="*/ 200721 w 802887"/>
              <a:gd name="connsiteY19" fmla="*/ 847493 h 1338147"/>
              <a:gd name="connsiteX20" fmla="*/ 557561 w 802887"/>
              <a:gd name="connsiteY20" fmla="*/ 892098 h 1338147"/>
              <a:gd name="connsiteX21" fmla="*/ 602165 w 802887"/>
              <a:gd name="connsiteY21" fmla="*/ 1025913 h 1338147"/>
              <a:gd name="connsiteX22" fmla="*/ 178419 w 802887"/>
              <a:gd name="connsiteY22" fmla="*/ 1092820 h 1338147"/>
              <a:gd name="connsiteX23" fmla="*/ 156117 w 802887"/>
              <a:gd name="connsiteY23" fmla="*/ 1159727 h 1338147"/>
              <a:gd name="connsiteX24" fmla="*/ 178419 w 802887"/>
              <a:gd name="connsiteY24" fmla="*/ 1271239 h 1338147"/>
              <a:gd name="connsiteX25" fmla="*/ 401443 w 802887"/>
              <a:gd name="connsiteY25" fmla="*/ 1338147 h 1338147"/>
              <a:gd name="connsiteX26" fmla="*/ 780585 w 802887"/>
              <a:gd name="connsiteY26" fmla="*/ 1315844 h 133814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</a:cxnLst>
            <a:rect l="l" t="t" r="r" b="b"/>
            <a:pathLst>
              <a:path w="802887" h="1338147">
                <a:moveTo>
                  <a:pt x="802887" y="0"/>
                </a:moveTo>
                <a:lnTo>
                  <a:pt x="802887" y="0"/>
                </a:lnTo>
                <a:lnTo>
                  <a:pt x="334536" y="22303"/>
                </a:lnTo>
                <a:cubicBezTo>
                  <a:pt x="230363" y="28256"/>
                  <a:pt x="123122" y="17720"/>
                  <a:pt x="22302" y="44605"/>
                </a:cubicBezTo>
                <a:cubicBezTo>
                  <a:pt x="-413" y="50662"/>
                  <a:pt x="7434" y="89210"/>
                  <a:pt x="0" y="111513"/>
                </a:cubicBezTo>
                <a:cubicBezTo>
                  <a:pt x="7434" y="148684"/>
                  <a:pt x="-9238" y="201998"/>
                  <a:pt x="22302" y="223025"/>
                </a:cubicBezTo>
                <a:cubicBezTo>
                  <a:pt x="40243" y="234985"/>
                  <a:pt x="170179" y="188601"/>
                  <a:pt x="200721" y="178420"/>
                </a:cubicBezTo>
                <a:cubicBezTo>
                  <a:pt x="282497" y="185854"/>
                  <a:pt x="365185" y="186452"/>
                  <a:pt x="446048" y="200722"/>
                </a:cubicBezTo>
                <a:cubicBezTo>
                  <a:pt x="492350" y="208893"/>
                  <a:pt x="579863" y="245327"/>
                  <a:pt x="579863" y="245327"/>
                </a:cubicBezTo>
                <a:cubicBezTo>
                  <a:pt x="587297" y="267630"/>
                  <a:pt x="610896" y="290407"/>
                  <a:pt x="602165" y="312235"/>
                </a:cubicBezTo>
                <a:cubicBezTo>
                  <a:pt x="592210" y="337122"/>
                  <a:pt x="561541" y="351582"/>
                  <a:pt x="535258" y="356839"/>
                </a:cubicBezTo>
                <a:cubicBezTo>
                  <a:pt x="447477" y="374395"/>
                  <a:pt x="356839" y="371708"/>
                  <a:pt x="267629" y="379142"/>
                </a:cubicBezTo>
                <a:cubicBezTo>
                  <a:pt x="223024" y="394010"/>
                  <a:pt x="94693" y="397666"/>
                  <a:pt x="133814" y="423747"/>
                </a:cubicBezTo>
                <a:cubicBezTo>
                  <a:pt x="156116" y="438615"/>
                  <a:pt x="176747" y="456365"/>
                  <a:pt x="200721" y="468352"/>
                </a:cubicBezTo>
                <a:cubicBezTo>
                  <a:pt x="296999" y="516491"/>
                  <a:pt x="502236" y="508701"/>
                  <a:pt x="557561" y="512957"/>
                </a:cubicBezTo>
                <a:cubicBezTo>
                  <a:pt x="583079" y="529969"/>
                  <a:pt x="669449" y="567770"/>
                  <a:pt x="646770" y="624469"/>
                </a:cubicBezTo>
                <a:cubicBezTo>
                  <a:pt x="636815" y="649356"/>
                  <a:pt x="606302" y="664667"/>
                  <a:pt x="579863" y="669074"/>
                </a:cubicBezTo>
                <a:cubicBezTo>
                  <a:pt x="425173" y="694855"/>
                  <a:pt x="267629" y="698810"/>
                  <a:pt x="111512" y="713678"/>
                </a:cubicBezTo>
                <a:cubicBezTo>
                  <a:pt x="118946" y="743415"/>
                  <a:pt x="116812" y="777384"/>
                  <a:pt x="133814" y="802888"/>
                </a:cubicBezTo>
                <a:cubicBezTo>
                  <a:pt x="148682" y="825190"/>
                  <a:pt x="176747" y="835506"/>
                  <a:pt x="200721" y="847493"/>
                </a:cubicBezTo>
                <a:cubicBezTo>
                  <a:pt x="297003" y="895634"/>
                  <a:pt x="502215" y="887841"/>
                  <a:pt x="557561" y="892098"/>
                </a:cubicBezTo>
                <a:cubicBezTo>
                  <a:pt x="610359" y="909697"/>
                  <a:pt x="709817" y="918260"/>
                  <a:pt x="602165" y="1025913"/>
                </a:cubicBezTo>
                <a:cubicBezTo>
                  <a:pt x="539451" y="1088628"/>
                  <a:pt x="179082" y="1092769"/>
                  <a:pt x="178419" y="1092820"/>
                </a:cubicBezTo>
                <a:cubicBezTo>
                  <a:pt x="170985" y="1115122"/>
                  <a:pt x="156117" y="1136218"/>
                  <a:pt x="156117" y="1159727"/>
                </a:cubicBezTo>
                <a:cubicBezTo>
                  <a:pt x="156117" y="1197634"/>
                  <a:pt x="151615" y="1244435"/>
                  <a:pt x="178419" y="1271239"/>
                </a:cubicBezTo>
                <a:cubicBezTo>
                  <a:pt x="196517" y="1289337"/>
                  <a:pt x="361015" y="1328040"/>
                  <a:pt x="401443" y="1338147"/>
                </a:cubicBezTo>
                <a:cubicBezTo>
                  <a:pt x="661275" y="1309276"/>
                  <a:pt x="534846" y="1315844"/>
                  <a:pt x="780585" y="1315844"/>
                </a:cubicBezTo>
              </a:path>
            </a:pathLst>
          </a:cu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98E9230-2C32-4F48-A140-7F750448C8FC}"/>
              </a:ext>
            </a:extLst>
          </p:cNvPr>
          <p:cNvSpPr/>
          <p:nvPr/>
        </p:nvSpPr>
        <p:spPr>
          <a:xfrm>
            <a:off x="4412404" y="1438102"/>
            <a:ext cx="2407847" cy="370535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0B9399D2-11EE-48D7-BB44-02CBA1D4C5CE}"/>
              </a:ext>
            </a:extLst>
          </p:cNvPr>
          <p:cNvSpPr/>
          <p:nvPr/>
        </p:nvSpPr>
        <p:spPr>
          <a:xfrm>
            <a:off x="4412404" y="2550646"/>
            <a:ext cx="444616" cy="369115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86DDC004-BB5C-44A3-8D85-A691907A92F7}"/>
              </a:ext>
            </a:extLst>
          </p:cNvPr>
          <p:cNvSpPr/>
          <p:nvPr/>
        </p:nvSpPr>
        <p:spPr>
          <a:xfrm>
            <a:off x="4412404" y="3117909"/>
            <a:ext cx="444616" cy="369115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C290D6-E2D5-4D63-A204-DEF45E1195E5}"/>
              </a:ext>
            </a:extLst>
          </p:cNvPr>
          <p:cNvSpPr txBox="1"/>
          <p:nvPr/>
        </p:nvSpPr>
        <p:spPr>
          <a:xfrm>
            <a:off x="2697121" y="2325024"/>
            <a:ext cx="15603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 N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dirty="0"/>
              <a:t> </a:t>
            </a:r>
          </a:p>
          <a:p>
            <a:r>
              <a:rPr lang="en-US" dirty="0"/>
              <a:t>HP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613B1F-52A2-4172-B35C-BC3563835473}"/>
              </a:ext>
            </a:extLst>
          </p:cNvPr>
          <p:cNvSpPr txBox="1"/>
          <p:nvPr/>
        </p:nvSpPr>
        <p:spPr>
          <a:xfrm>
            <a:off x="2700362" y="3050826"/>
            <a:ext cx="15603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 N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dirty="0"/>
              <a:t> </a:t>
            </a:r>
          </a:p>
          <a:p>
            <a:r>
              <a:rPr lang="en-US" dirty="0"/>
              <a:t>HP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</a:t>
            </a:r>
            <a:endParaRPr lang="en-US" dirty="0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3335DC34-AF14-4143-8779-C32F07F9448F}"/>
              </a:ext>
            </a:extLst>
          </p:cNvPr>
          <p:cNvSpPr/>
          <p:nvPr/>
        </p:nvSpPr>
        <p:spPr>
          <a:xfrm>
            <a:off x="3602215" y="2694351"/>
            <a:ext cx="1342379" cy="817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2CACEC55-E92A-4242-B9C8-6573BB5F668A}"/>
              </a:ext>
            </a:extLst>
          </p:cNvPr>
          <p:cNvSpPr/>
          <p:nvPr/>
        </p:nvSpPr>
        <p:spPr>
          <a:xfrm>
            <a:off x="3563540" y="3279788"/>
            <a:ext cx="1342379" cy="817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085AEB7-0A19-437B-876F-B7D6DD5C10D6}"/>
              </a:ext>
            </a:extLst>
          </p:cNvPr>
          <p:cNvSpPr/>
          <p:nvPr/>
        </p:nvSpPr>
        <p:spPr>
          <a:xfrm>
            <a:off x="6635693" y="2735203"/>
            <a:ext cx="444616" cy="382489"/>
          </a:xfrm>
          <a:prstGeom prst="rect">
            <a:avLst/>
          </a:prstGeom>
          <a:solidFill>
            <a:schemeClr val="accent1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D72F97DB-F780-466C-A67E-657F90C5EA00}"/>
              </a:ext>
            </a:extLst>
          </p:cNvPr>
          <p:cNvSpPr/>
          <p:nvPr/>
        </p:nvSpPr>
        <p:spPr>
          <a:xfrm>
            <a:off x="6473336" y="2725739"/>
            <a:ext cx="953889" cy="45719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11F9D24B-188E-4C3C-8B00-01C852D1C8E0}"/>
              </a:ext>
            </a:extLst>
          </p:cNvPr>
          <p:cNvSpPr/>
          <p:nvPr/>
        </p:nvSpPr>
        <p:spPr>
          <a:xfrm rot="10800000">
            <a:off x="6473335" y="3090847"/>
            <a:ext cx="953889" cy="45719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2AD974F-36F7-4AB3-97FA-F25174DBD431}"/>
              </a:ext>
            </a:extLst>
          </p:cNvPr>
          <p:cNvSpPr txBox="1"/>
          <p:nvPr/>
        </p:nvSpPr>
        <p:spPr>
          <a:xfrm>
            <a:off x="7020078" y="2670544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N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D97C289-3E43-461B-B3C8-0B6854DA3C06}"/>
              </a:ext>
            </a:extLst>
          </p:cNvPr>
          <p:cNvSpPr txBox="1"/>
          <p:nvPr/>
        </p:nvSpPr>
        <p:spPr>
          <a:xfrm>
            <a:off x="6999245" y="3063203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K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DA91129-D29C-41BE-9155-AE368B1509B6}"/>
              </a:ext>
            </a:extLst>
          </p:cNvPr>
          <p:cNvSpPr txBox="1"/>
          <p:nvPr/>
        </p:nvSpPr>
        <p:spPr>
          <a:xfrm>
            <a:off x="4081946" y="5637565"/>
            <a:ext cx="578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TH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FB16477-F305-4493-B402-F614FF260F6D}"/>
              </a:ext>
            </a:extLst>
          </p:cNvPr>
          <p:cNvSpPr/>
          <p:nvPr/>
        </p:nvSpPr>
        <p:spPr>
          <a:xfrm>
            <a:off x="4143864" y="4900421"/>
            <a:ext cx="382715" cy="241370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Arrow: Curved Left 28">
            <a:extLst>
              <a:ext uri="{FF2B5EF4-FFF2-40B4-BE49-F238E27FC236}">
                <a16:creationId xmlns:a16="http://schemas.microsoft.com/office/drawing/2014/main" id="{ACF513C0-621D-4DEA-B590-958AF33F564D}"/>
              </a:ext>
            </a:extLst>
          </p:cNvPr>
          <p:cNvSpPr/>
          <p:nvPr/>
        </p:nvSpPr>
        <p:spPr>
          <a:xfrm rot="10800000">
            <a:off x="3638406" y="4888669"/>
            <a:ext cx="478301" cy="1066793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E517500-D4CF-485E-A1FA-89A9A933FCF2}"/>
              </a:ext>
            </a:extLst>
          </p:cNvPr>
          <p:cNvSpPr txBox="1"/>
          <p:nvPr/>
        </p:nvSpPr>
        <p:spPr>
          <a:xfrm>
            <a:off x="4752546" y="4576195"/>
            <a:ext cx="999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KA/PKC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867E77D-3D8F-4BB6-A6CE-2932F0874CA3}"/>
              </a:ext>
            </a:extLst>
          </p:cNvPr>
          <p:cNvCxnSpPr>
            <a:cxnSpLocks/>
          </p:cNvCxnSpPr>
          <p:nvPr/>
        </p:nvCxnSpPr>
        <p:spPr>
          <a:xfrm>
            <a:off x="4675218" y="3547826"/>
            <a:ext cx="469043" cy="1066119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B9CA35D5-6C4D-4B95-B6EF-B6707C3470B4}"/>
              </a:ext>
            </a:extLst>
          </p:cNvPr>
          <p:cNvCxnSpPr>
            <a:cxnSpLocks/>
          </p:cNvCxnSpPr>
          <p:nvPr/>
        </p:nvCxnSpPr>
        <p:spPr>
          <a:xfrm flipV="1">
            <a:off x="4514288" y="3471195"/>
            <a:ext cx="341864" cy="13576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4CEB20E-B84F-4172-9122-7E39DFDB02B8}"/>
              </a:ext>
            </a:extLst>
          </p:cNvPr>
          <p:cNvCxnSpPr>
            <a:cxnSpLocks/>
          </p:cNvCxnSpPr>
          <p:nvPr/>
        </p:nvCxnSpPr>
        <p:spPr>
          <a:xfrm flipV="1">
            <a:off x="4820545" y="3313488"/>
            <a:ext cx="1828700" cy="591786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F7391B4-EADA-486F-BD8B-D8A684C5BDB1}"/>
              </a:ext>
            </a:extLst>
          </p:cNvPr>
          <p:cNvCxnSpPr>
            <a:cxnSpLocks/>
          </p:cNvCxnSpPr>
          <p:nvPr/>
        </p:nvCxnSpPr>
        <p:spPr>
          <a:xfrm>
            <a:off x="6566763" y="3178738"/>
            <a:ext cx="160665" cy="33501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Rectangle 48">
            <a:extLst>
              <a:ext uri="{FF2B5EF4-FFF2-40B4-BE49-F238E27FC236}">
                <a16:creationId xmlns:a16="http://schemas.microsoft.com/office/drawing/2014/main" id="{0E1599AB-E47D-460F-8DD2-8BB3AE651E6F}"/>
              </a:ext>
            </a:extLst>
          </p:cNvPr>
          <p:cNvSpPr/>
          <p:nvPr/>
        </p:nvSpPr>
        <p:spPr>
          <a:xfrm>
            <a:off x="6716347" y="2190610"/>
            <a:ext cx="811232" cy="381379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EA95FB-E87C-4E9E-9579-363A46AAE763}"/>
              </a:ext>
            </a:extLst>
          </p:cNvPr>
          <p:cNvSpPr txBox="1"/>
          <p:nvPr/>
        </p:nvSpPr>
        <p:spPr>
          <a:xfrm>
            <a:off x="7895086" y="1909186"/>
            <a:ext cx="774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</a:t>
            </a:r>
          </a:p>
        </p:txBody>
      </p:sp>
      <p:sp>
        <p:nvSpPr>
          <p:cNvPr id="52" name="Arrow: Right 51">
            <a:extLst>
              <a:ext uri="{FF2B5EF4-FFF2-40B4-BE49-F238E27FC236}">
                <a16:creationId xmlns:a16="http://schemas.microsoft.com/office/drawing/2014/main" id="{34057DF1-796D-4246-B564-461E0ECB2F6E}"/>
              </a:ext>
            </a:extLst>
          </p:cNvPr>
          <p:cNvSpPr/>
          <p:nvPr/>
        </p:nvSpPr>
        <p:spPr>
          <a:xfrm rot="10800000">
            <a:off x="7552006" y="2204230"/>
            <a:ext cx="414502" cy="247122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6CEA3FE-5D6A-4CD7-A0A2-8B9431443DE1}"/>
              </a:ext>
            </a:extLst>
          </p:cNvPr>
          <p:cNvSpPr txBox="1"/>
          <p:nvPr/>
        </p:nvSpPr>
        <p:spPr>
          <a:xfrm>
            <a:off x="5808331" y="1945258"/>
            <a:ext cx="75373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MAPK</a:t>
            </a:r>
          </a:p>
        </p:txBody>
      </p:sp>
      <p:sp>
        <p:nvSpPr>
          <p:cNvPr id="54" name="Arrow: Right 53">
            <a:extLst>
              <a:ext uri="{FF2B5EF4-FFF2-40B4-BE49-F238E27FC236}">
                <a16:creationId xmlns:a16="http://schemas.microsoft.com/office/drawing/2014/main" id="{6EF4263D-0F14-47EE-9AAC-A88A152539A7}"/>
              </a:ext>
            </a:extLst>
          </p:cNvPr>
          <p:cNvSpPr/>
          <p:nvPr/>
        </p:nvSpPr>
        <p:spPr>
          <a:xfrm rot="10800000">
            <a:off x="6290127" y="2327791"/>
            <a:ext cx="414502" cy="111100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Arrow: Right 54">
            <a:extLst>
              <a:ext uri="{FF2B5EF4-FFF2-40B4-BE49-F238E27FC236}">
                <a16:creationId xmlns:a16="http://schemas.microsoft.com/office/drawing/2014/main" id="{AA768C7F-9220-481B-86E2-3577E9D27A4D}"/>
              </a:ext>
            </a:extLst>
          </p:cNvPr>
          <p:cNvSpPr/>
          <p:nvPr/>
        </p:nvSpPr>
        <p:spPr>
          <a:xfrm rot="12407240">
            <a:off x="5458174" y="1970990"/>
            <a:ext cx="414502" cy="111100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3D4E0B1-E5E4-4DAE-AFF9-D33C9537E154}"/>
              </a:ext>
            </a:extLst>
          </p:cNvPr>
          <p:cNvSpPr txBox="1"/>
          <p:nvPr/>
        </p:nvSpPr>
        <p:spPr>
          <a:xfrm flipH="1">
            <a:off x="4854434" y="1518465"/>
            <a:ext cx="104114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NHERF-1</a:t>
            </a:r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1A87C704-EC1D-4650-AA7C-28BF90ED0E0A}"/>
              </a:ext>
            </a:extLst>
          </p:cNvPr>
          <p:cNvSpPr/>
          <p:nvPr/>
        </p:nvSpPr>
        <p:spPr>
          <a:xfrm>
            <a:off x="5769535" y="1484766"/>
            <a:ext cx="215450" cy="326500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p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D4D7C3A-72EA-4F39-AC90-89E14CBB01ED}"/>
              </a:ext>
            </a:extLst>
          </p:cNvPr>
          <p:cNvCxnSpPr>
            <a:cxnSpLocks/>
          </p:cNvCxnSpPr>
          <p:nvPr/>
        </p:nvCxnSpPr>
        <p:spPr>
          <a:xfrm flipV="1">
            <a:off x="4796544" y="1909186"/>
            <a:ext cx="600341" cy="562253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E20B14AC-34F1-496C-BD86-EB0B71F6C5DA}"/>
              </a:ext>
            </a:extLst>
          </p:cNvPr>
          <p:cNvCxnSpPr>
            <a:cxnSpLocks/>
          </p:cNvCxnSpPr>
          <p:nvPr/>
        </p:nvCxnSpPr>
        <p:spPr>
          <a:xfrm>
            <a:off x="4696741" y="2298308"/>
            <a:ext cx="160665" cy="33501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: Rounded Corners 61">
            <a:extLst>
              <a:ext uri="{FF2B5EF4-FFF2-40B4-BE49-F238E27FC236}">
                <a16:creationId xmlns:a16="http://schemas.microsoft.com/office/drawing/2014/main" id="{93A11F09-1E34-44D7-A781-93A319838068}"/>
              </a:ext>
            </a:extLst>
          </p:cNvPr>
          <p:cNvSpPr/>
          <p:nvPr/>
        </p:nvSpPr>
        <p:spPr>
          <a:xfrm>
            <a:off x="4001902" y="4117245"/>
            <a:ext cx="673316" cy="288888"/>
          </a:xfrm>
          <a:prstGeom prst="roundRect">
            <a:avLst/>
          </a:prstGeom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Arrow: Right 62">
            <a:extLst>
              <a:ext uri="{FF2B5EF4-FFF2-40B4-BE49-F238E27FC236}">
                <a16:creationId xmlns:a16="http://schemas.microsoft.com/office/drawing/2014/main" id="{86F65DB4-88B9-415C-B3D6-86E33F776A4D}"/>
              </a:ext>
            </a:extLst>
          </p:cNvPr>
          <p:cNvSpPr/>
          <p:nvPr/>
        </p:nvSpPr>
        <p:spPr>
          <a:xfrm>
            <a:off x="3514641" y="4229481"/>
            <a:ext cx="1342379" cy="8170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2A0AC3-F48A-4A07-8014-67238CECCCB8}"/>
              </a:ext>
            </a:extLst>
          </p:cNvPr>
          <p:cNvSpPr txBox="1"/>
          <p:nvPr/>
        </p:nvSpPr>
        <p:spPr>
          <a:xfrm>
            <a:off x="2730200" y="4023881"/>
            <a:ext cx="15603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 Na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dirty="0"/>
              <a:t> </a:t>
            </a:r>
          </a:p>
          <a:p>
            <a:r>
              <a:rPr lang="en-US" dirty="0"/>
              <a:t>H</a:t>
            </a:r>
            <a:r>
              <a:rPr lang="en-US" sz="18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dirty="0"/>
              <a:t>P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</a:t>
            </a:r>
            <a:endParaRPr lang="en-US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84E66E8-96F6-4466-9B25-0058AA6EB8A0}"/>
              </a:ext>
            </a:extLst>
          </p:cNvPr>
          <p:cNvSpPr txBox="1"/>
          <p:nvPr/>
        </p:nvSpPr>
        <p:spPr>
          <a:xfrm>
            <a:off x="4952568" y="2557733"/>
            <a:ext cx="112294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NaPi2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5CD2D91-C195-425C-84C9-DB1EC23415A1}"/>
              </a:ext>
            </a:extLst>
          </p:cNvPr>
          <p:cNvSpPr txBox="1"/>
          <p:nvPr/>
        </p:nvSpPr>
        <p:spPr>
          <a:xfrm>
            <a:off x="4949979" y="3157105"/>
            <a:ext cx="92549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NaPi2c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748B88D-A6AE-4542-9ECA-1F481E4F7D8E}"/>
              </a:ext>
            </a:extLst>
          </p:cNvPr>
          <p:cNvSpPr txBox="1"/>
          <p:nvPr/>
        </p:nvSpPr>
        <p:spPr>
          <a:xfrm>
            <a:off x="3832291" y="4420977"/>
            <a:ext cx="690997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>
                <a:solidFill>
                  <a:schemeClr val="tx1"/>
                </a:solidFill>
              </a:rPr>
              <a:t>PiT2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A2E5EF2-4351-4B67-982F-327AEA1385CC}"/>
              </a:ext>
            </a:extLst>
          </p:cNvPr>
          <p:cNvSpPr txBox="1"/>
          <p:nvPr/>
        </p:nvSpPr>
        <p:spPr>
          <a:xfrm>
            <a:off x="2152290" y="4913292"/>
            <a:ext cx="145873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PTH Receptor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DDF53A6-4D04-4B26-AB86-E520BC5BABC2}"/>
              </a:ext>
            </a:extLst>
          </p:cNvPr>
          <p:cNvSpPr txBox="1"/>
          <p:nvPr/>
        </p:nvSpPr>
        <p:spPr>
          <a:xfrm>
            <a:off x="6734205" y="1811319"/>
            <a:ext cx="800219" cy="369332"/>
          </a:xfrm>
          <a:prstGeom prst="rect">
            <a:avLst/>
          </a:prstGeom>
          <a:solidFill>
            <a:srgbClr val="92D05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txBody>
          <a:bodyPr wrap="none" rtlCol="0">
            <a:spAutoFit/>
          </a:bodyPr>
          <a:lstStyle/>
          <a:p>
            <a:r>
              <a:rPr lang="en-US" dirty="0"/>
              <a:t>Klotho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3AC3059-38F9-4AB6-B23E-986ACC26096E}"/>
              </a:ext>
            </a:extLst>
          </p:cNvPr>
          <p:cNvSpPr txBox="1"/>
          <p:nvPr/>
        </p:nvSpPr>
        <p:spPr>
          <a:xfrm>
            <a:off x="7634019" y="2705774"/>
            <a:ext cx="841384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Na K </a:t>
            </a:r>
          </a:p>
          <a:p>
            <a:r>
              <a:rPr lang="en-US" dirty="0"/>
              <a:t>ATPas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490CFAB-8AB5-409F-B02C-E4423DDDB2C0}"/>
              </a:ext>
            </a:extLst>
          </p:cNvPr>
          <p:cNvSpPr txBox="1"/>
          <p:nvPr/>
        </p:nvSpPr>
        <p:spPr>
          <a:xfrm>
            <a:off x="6653195" y="2194804"/>
            <a:ext cx="899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CF541C3-7365-4C89-92F1-7865CF577E84}"/>
              </a:ext>
            </a:extLst>
          </p:cNvPr>
          <p:cNvSpPr txBox="1"/>
          <p:nvPr/>
        </p:nvSpPr>
        <p:spPr>
          <a:xfrm>
            <a:off x="8982766" y="1861152"/>
            <a:ext cx="164737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 also </a:t>
            </a:r>
          </a:p>
          <a:p>
            <a:r>
              <a:rPr lang="en-US" dirty="0"/>
              <a:t>Stimulates PTH </a:t>
            </a:r>
          </a:p>
          <a:p>
            <a:r>
              <a:rPr lang="en-US" dirty="0"/>
              <a:t>secretion</a:t>
            </a:r>
          </a:p>
          <a:p>
            <a:r>
              <a:rPr lang="en-US" dirty="0"/>
              <a:t>In parathyroid</a:t>
            </a:r>
          </a:p>
        </p:txBody>
      </p:sp>
      <p:sp>
        <p:nvSpPr>
          <p:cNvPr id="56" name="Arrow: Right 55">
            <a:extLst>
              <a:ext uri="{FF2B5EF4-FFF2-40B4-BE49-F238E27FC236}">
                <a16:creationId xmlns:a16="http://schemas.microsoft.com/office/drawing/2014/main" id="{5C9FCA07-41B3-4C49-8B30-C4EA0EAFBF76}"/>
              </a:ext>
            </a:extLst>
          </p:cNvPr>
          <p:cNvSpPr/>
          <p:nvPr/>
        </p:nvSpPr>
        <p:spPr>
          <a:xfrm>
            <a:off x="7033617" y="871095"/>
            <a:ext cx="1412956" cy="247122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reeform: Shape 2">
            <a:extLst>
              <a:ext uri="{FF2B5EF4-FFF2-40B4-BE49-F238E27FC236}">
                <a16:creationId xmlns:a16="http://schemas.microsoft.com/office/drawing/2014/main" id="{BF693723-631F-464A-8B72-52AE62D2F523}"/>
              </a:ext>
            </a:extLst>
          </p:cNvPr>
          <p:cNvSpPr/>
          <p:nvPr/>
        </p:nvSpPr>
        <p:spPr>
          <a:xfrm>
            <a:off x="9546791" y="436228"/>
            <a:ext cx="802006" cy="1149291"/>
          </a:xfrm>
          <a:custGeom>
            <a:avLst/>
            <a:gdLst>
              <a:gd name="connsiteX0" fmla="*/ 620666 w 802006"/>
              <a:gd name="connsiteY0" fmla="*/ 159390 h 1149291"/>
              <a:gd name="connsiteX1" fmla="*/ 486442 w 802006"/>
              <a:gd name="connsiteY1" fmla="*/ 92278 h 1149291"/>
              <a:gd name="connsiteX2" fmla="*/ 335440 w 802006"/>
              <a:gd name="connsiteY2" fmla="*/ 25166 h 1149291"/>
              <a:gd name="connsiteX3" fmla="*/ 134104 w 802006"/>
              <a:gd name="connsiteY3" fmla="*/ 0 h 1149291"/>
              <a:gd name="connsiteX4" fmla="*/ 50215 w 802006"/>
              <a:gd name="connsiteY4" fmla="*/ 16778 h 1149291"/>
              <a:gd name="connsiteX5" fmla="*/ 50215 w 802006"/>
              <a:gd name="connsiteY5" fmla="*/ 285225 h 1149291"/>
              <a:gd name="connsiteX6" fmla="*/ 100548 w 802006"/>
              <a:gd name="connsiteY6" fmla="*/ 360726 h 1149291"/>
              <a:gd name="connsiteX7" fmla="*/ 117326 w 802006"/>
              <a:gd name="connsiteY7" fmla="*/ 402671 h 1149291"/>
              <a:gd name="connsiteX8" fmla="*/ 176049 w 802006"/>
              <a:gd name="connsiteY8" fmla="*/ 511728 h 1149291"/>
              <a:gd name="connsiteX9" fmla="*/ 226383 w 802006"/>
              <a:gd name="connsiteY9" fmla="*/ 587229 h 1149291"/>
              <a:gd name="connsiteX10" fmla="*/ 259939 w 802006"/>
              <a:gd name="connsiteY10" fmla="*/ 662730 h 1149291"/>
              <a:gd name="connsiteX11" fmla="*/ 251550 w 802006"/>
              <a:gd name="connsiteY11" fmla="*/ 796954 h 1149291"/>
              <a:gd name="connsiteX12" fmla="*/ 234772 w 802006"/>
              <a:gd name="connsiteY12" fmla="*/ 838899 h 1149291"/>
              <a:gd name="connsiteX13" fmla="*/ 226383 w 802006"/>
              <a:gd name="connsiteY13" fmla="*/ 964733 h 1149291"/>
              <a:gd name="connsiteX14" fmla="*/ 234772 w 802006"/>
              <a:gd name="connsiteY14" fmla="*/ 1031845 h 1149291"/>
              <a:gd name="connsiteX15" fmla="*/ 276717 w 802006"/>
              <a:gd name="connsiteY15" fmla="*/ 1073790 h 1149291"/>
              <a:gd name="connsiteX16" fmla="*/ 419330 w 802006"/>
              <a:gd name="connsiteY16" fmla="*/ 1140902 h 1149291"/>
              <a:gd name="connsiteX17" fmla="*/ 528387 w 802006"/>
              <a:gd name="connsiteY17" fmla="*/ 1149291 h 1149291"/>
              <a:gd name="connsiteX18" fmla="*/ 671000 w 802006"/>
              <a:gd name="connsiteY18" fmla="*/ 1115735 h 1149291"/>
              <a:gd name="connsiteX19" fmla="*/ 687778 w 802006"/>
              <a:gd name="connsiteY19" fmla="*/ 1048623 h 1149291"/>
              <a:gd name="connsiteX20" fmla="*/ 704556 w 802006"/>
              <a:gd name="connsiteY20" fmla="*/ 989900 h 1149291"/>
              <a:gd name="connsiteX21" fmla="*/ 712945 w 802006"/>
              <a:gd name="connsiteY21" fmla="*/ 956344 h 1149291"/>
              <a:gd name="connsiteX22" fmla="*/ 788446 w 802006"/>
              <a:gd name="connsiteY22" fmla="*/ 880844 h 1149291"/>
              <a:gd name="connsiteX23" fmla="*/ 780057 w 802006"/>
              <a:gd name="connsiteY23" fmla="*/ 436227 h 1149291"/>
              <a:gd name="connsiteX24" fmla="*/ 771668 w 802006"/>
              <a:gd name="connsiteY24" fmla="*/ 411060 h 1149291"/>
              <a:gd name="connsiteX25" fmla="*/ 754890 w 802006"/>
              <a:gd name="connsiteY25" fmla="*/ 343948 h 1149291"/>
              <a:gd name="connsiteX26" fmla="*/ 721334 w 802006"/>
              <a:gd name="connsiteY26" fmla="*/ 293614 h 1149291"/>
              <a:gd name="connsiteX27" fmla="*/ 696167 w 802006"/>
              <a:gd name="connsiteY27" fmla="*/ 226502 h 1149291"/>
              <a:gd name="connsiteX28" fmla="*/ 671000 w 802006"/>
              <a:gd name="connsiteY28" fmla="*/ 201335 h 1149291"/>
              <a:gd name="connsiteX29" fmla="*/ 620666 w 802006"/>
              <a:gd name="connsiteY29" fmla="*/ 159390 h 11492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</a:cxnLst>
            <a:rect l="l" t="t" r="r" b="b"/>
            <a:pathLst>
              <a:path w="802006" h="1149291">
                <a:moveTo>
                  <a:pt x="620666" y="159390"/>
                </a:moveTo>
                <a:cubicBezTo>
                  <a:pt x="589906" y="141214"/>
                  <a:pt x="611932" y="158011"/>
                  <a:pt x="486442" y="92278"/>
                </a:cubicBezTo>
                <a:cubicBezTo>
                  <a:pt x="462784" y="79886"/>
                  <a:pt x="377606" y="32193"/>
                  <a:pt x="335440" y="25166"/>
                </a:cubicBezTo>
                <a:cubicBezTo>
                  <a:pt x="268726" y="14047"/>
                  <a:pt x="201216" y="8389"/>
                  <a:pt x="134104" y="0"/>
                </a:cubicBezTo>
                <a:cubicBezTo>
                  <a:pt x="106141" y="5593"/>
                  <a:pt x="76056" y="4719"/>
                  <a:pt x="50215" y="16778"/>
                </a:cubicBezTo>
                <a:cubicBezTo>
                  <a:pt x="-53079" y="64982"/>
                  <a:pt x="32062" y="225815"/>
                  <a:pt x="50215" y="285225"/>
                </a:cubicBezTo>
                <a:cubicBezTo>
                  <a:pt x="59054" y="314152"/>
                  <a:pt x="85542" y="334464"/>
                  <a:pt x="100548" y="360726"/>
                </a:cubicBezTo>
                <a:cubicBezTo>
                  <a:pt x="108019" y="373801"/>
                  <a:pt x="110592" y="389202"/>
                  <a:pt x="117326" y="402671"/>
                </a:cubicBezTo>
                <a:cubicBezTo>
                  <a:pt x="135790" y="439600"/>
                  <a:pt x="155045" y="476183"/>
                  <a:pt x="176049" y="511728"/>
                </a:cubicBezTo>
                <a:cubicBezTo>
                  <a:pt x="191437" y="537768"/>
                  <a:pt x="210531" y="561469"/>
                  <a:pt x="226383" y="587229"/>
                </a:cubicBezTo>
                <a:cubicBezTo>
                  <a:pt x="239819" y="609062"/>
                  <a:pt x="250651" y="639509"/>
                  <a:pt x="259939" y="662730"/>
                </a:cubicBezTo>
                <a:cubicBezTo>
                  <a:pt x="257143" y="707471"/>
                  <a:pt x="257890" y="752576"/>
                  <a:pt x="251550" y="796954"/>
                </a:cubicBezTo>
                <a:cubicBezTo>
                  <a:pt x="249420" y="811861"/>
                  <a:pt x="237006" y="824007"/>
                  <a:pt x="234772" y="838899"/>
                </a:cubicBezTo>
                <a:cubicBezTo>
                  <a:pt x="228536" y="880472"/>
                  <a:pt x="229179" y="922788"/>
                  <a:pt x="226383" y="964733"/>
                </a:cubicBezTo>
                <a:cubicBezTo>
                  <a:pt x="229179" y="987104"/>
                  <a:pt x="225324" y="1011375"/>
                  <a:pt x="234772" y="1031845"/>
                </a:cubicBezTo>
                <a:cubicBezTo>
                  <a:pt x="243058" y="1049798"/>
                  <a:pt x="261938" y="1060653"/>
                  <a:pt x="276717" y="1073790"/>
                </a:cubicBezTo>
                <a:cubicBezTo>
                  <a:pt x="317528" y="1110066"/>
                  <a:pt x="363813" y="1128090"/>
                  <a:pt x="419330" y="1140902"/>
                </a:cubicBezTo>
                <a:cubicBezTo>
                  <a:pt x="454856" y="1149100"/>
                  <a:pt x="492035" y="1146495"/>
                  <a:pt x="528387" y="1149291"/>
                </a:cubicBezTo>
                <a:cubicBezTo>
                  <a:pt x="575925" y="1138106"/>
                  <a:pt x="629710" y="1141813"/>
                  <a:pt x="671000" y="1115735"/>
                </a:cubicBezTo>
                <a:cubicBezTo>
                  <a:pt x="690496" y="1103422"/>
                  <a:pt x="681443" y="1070795"/>
                  <a:pt x="687778" y="1048623"/>
                </a:cubicBezTo>
                <a:cubicBezTo>
                  <a:pt x="693371" y="1029049"/>
                  <a:pt x="699200" y="1009540"/>
                  <a:pt x="704556" y="989900"/>
                </a:cubicBezTo>
                <a:cubicBezTo>
                  <a:pt x="707590" y="978777"/>
                  <a:pt x="705915" y="965483"/>
                  <a:pt x="712945" y="956344"/>
                </a:cubicBezTo>
                <a:cubicBezTo>
                  <a:pt x="734646" y="928134"/>
                  <a:pt x="788446" y="880844"/>
                  <a:pt x="788446" y="880844"/>
                </a:cubicBezTo>
                <a:cubicBezTo>
                  <a:pt x="811596" y="695640"/>
                  <a:pt x="802651" y="797733"/>
                  <a:pt x="780057" y="436227"/>
                </a:cubicBezTo>
                <a:cubicBezTo>
                  <a:pt x="779505" y="427401"/>
                  <a:pt x="773995" y="419591"/>
                  <a:pt x="771668" y="411060"/>
                </a:cubicBezTo>
                <a:cubicBezTo>
                  <a:pt x="765601" y="388813"/>
                  <a:pt x="767681" y="363134"/>
                  <a:pt x="754890" y="343948"/>
                </a:cubicBezTo>
                <a:lnTo>
                  <a:pt x="721334" y="293614"/>
                </a:lnTo>
                <a:cubicBezTo>
                  <a:pt x="713724" y="255564"/>
                  <a:pt x="718905" y="253788"/>
                  <a:pt x="696167" y="226502"/>
                </a:cubicBezTo>
                <a:cubicBezTo>
                  <a:pt x="688572" y="217388"/>
                  <a:pt x="680114" y="208930"/>
                  <a:pt x="671000" y="201335"/>
                </a:cubicBezTo>
                <a:cubicBezTo>
                  <a:pt x="663255" y="194880"/>
                  <a:pt x="651426" y="177566"/>
                  <a:pt x="620666" y="159390"/>
                </a:cubicBez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Freeform: Shape 59">
            <a:extLst>
              <a:ext uri="{FF2B5EF4-FFF2-40B4-BE49-F238E27FC236}">
                <a16:creationId xmlns:a16="http://schemas.microsoft.com/office/drawing/2014/main" id="{865169AD-9589-4902-A692-0218548C6042}"/>
              </a:ext>
            </a:extLst>
          </p:cNvPr>
          <p:cNvSpPr/>
          <p:nvPr/>
        </p:nvSpPr>
        <p:spPr>
          <a:xfrm flipH="1">
            <a:off x="10348797" y="433809"/>
            <a:ext cx="813694" cy="1149291"/>
          </a:xfrm>
          <a:custGeom>
            <a:avLst/>
            <a:gdLst>
              <a:gd name="connsiteX0" fmla="*/ 620666 w 802006"/>
              <a:gd name="connsiteY0" fmla="*/ 159390 h 1149291"/>
              <a:gd name="connsiteX1" fmla="*/ 486442 w 802006"/>
              <a:gd name="connsiteY1" fmla="*/ 92278 h 1149291"/>
              <a:gd name="connsiteX2" fmla="*/ 335440 w 802006"/>
              <a:gd name="connsiteY2" fmla="*/ 25166 h 1149291"/>
              <a:gd name="connsiteX3" fmla="*/ 134104 w 802006"/>
              <a:gd name="connsiteY3" fmla="*/ 0 h 1149291"/>
              <a:gd name="connsiteX4" fmla="*/ 50215 w 802006"/>
              <a:gd name="connsiteY4" fmla="*/ 16778 h 1149291"/>
              <a:gd name="connsiteX5" fmla="*/ 50215 w 802006"/>
              <a:gd name="connsiteY5" fmla="*/ 285225 h 1149291"/>
              <a:gd name="connsiteX6" fmla="*/ 100548 w 802006"/>
              <a:gd name="connsiteY6" fmla="*/ 360726 h 1149291"/>
              <a:gd name="connsiteX7" fmla="*/ 117326 w 802006"/>
              <a:gd name="connsiteY7" fmla="*/ 402671 h 1149291"/>
              <a:gd name="connsiteX8" fmla="*/ 176049 w 802006"/>
              <a:gd name="connsiteY8" fmla="*/ 511728 h 1149291"/>
              <a:gd name="connsiteX9" fmla="*/ 226383 w 802006"/>
              <a:gd name="connsiteY9" fmla="*/ 587229 h 1149291"/>
              <a:gd name="connsiteX10" fmla="*/ 259939 w 802006"/>
              <a:gd name="connsiteY10" fmla="*/ 662730 h 1149291"/>
              <a:gd name="connsiteX11" fmla="*/ 251550 w 802006"/>
              <a:gd name="connsiteY11" fmla="*/ 796954 h 1149291"/>
              <a:gd name="connsiteX12" fmla="*/ 234772 w 802006"/>
              <a:gd name="connsiteY12" fmla="*/ 838899 h 1149291"/>
              <a:gd name="connsiteX13" fmla="*/ 226383 w 802006"/>
              <a:gd name="connsiteY13" fmla="*/ 964733 h 1149291"/>
              <a:gd name="connsiteX14" fmla="*/ 234772 w 802006"/>
              <a:gd name="connsiteY14" fmla="*/ 1031845 h 1149291"/>
              <a:gd name="connsiteX15" fmla="*/ 276717 w 802006"/>
              <a:gd name="connsiteY15" fmla="*/ 1073790 h 1149291"/>
              <a:gd name="connsiteX16" fmla="*/ 419330 w 802006"/>
              <a:gd name="connsiteY16" fmla="*/ 1140902 h 1149291"/>
              <a:gd name="connsiteX17" fmla="*/ 528387 w 802006"/>
              <a:gd name="connsiteY17" fmla="*/ 1149291 h 1149291"/>
              <a:gd name="connsiteX18" fmla="*/ 671000 w 802006"/>
              <a:gd name="connsiteY18" fmla="*/ 1115735 h 1149291"/>
              <a:gd name="connsiteX19" fmla="*/ 687778 w 802006"/>
              <a:gd name="connsiteY19" fmla="*/ 1048623 h 1149291"/>
              <a:gd name="connsiteX20" fmla="*/ 704556 w 802006"/>
              <a:gd name="connsiteY20" fmla="*/ 989900 h 1149291"/>
              <a:gd name="connsiteX21" fmla="*/ 712945 w 802006"/>
              <a:gd name="connsiteY21" fmla="*/ 956344 h 1149291"/>
              <a:gd name="connsiteX22" fmla="*/ 788446 w 802006"/>
              <a:gd name="connsiteY22" fmla="*/ 880844 h 1149291"/>
              <a:gd name="connsiteX23" fmla="*/ 780057 w 802006"/>
              <a:gd name="connsiteY23" fmla="*/ 436227 h 1149291"/>
              <a:gd name="connsiteX24" fmla="*/ 771668 w 802006"/>
              <a:gd name="connsiteY24" fmla="*/ 411060 h 1149291"/>
              <a:gd name="connsiteX25" fmla="*/ 754890 w 802006"/>
              <a:gd name="connsiteY25" fmla="*/ 343948 h 1149291"/>
              <a:gd name="connsiteX26" fmla="*/ 721334 w 802006"/>
              <a:gd name="connsiteY26" fmla="*/ 293614 h 1149291"/>
              <a:gd name="connsiteX27" fmla="*/ 696167 w 802006"/>
              <a:gd name="connsiteY27" fmla="*/ 226502 h 1149291"/>
              <a:gd name="connsiteX28" fmla="*/ 671000 w 802006"/>
              <a:gd name="connsiteY28" fmla="*/ 201335 h 1149291"/>
              <a:gd name="connsiteX29" fmla="*/ 620666 w 802006"/>
              <a:gd name="connsiteY29" fmla="*/ 159390 h 11492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</a:cxnLst>
            <a:rect l="l" t="t" r="r" b="b"/>
            <a:pathLst>
              <a:path w="802006" h="1149291">
                <a:moveTo>
                  <a:pt x="620666" y="159390"/>
                </a:moveTo>
                <a:cubicBezTo>
                  <a:pt x="589906" y="141214"/>
                  <a:pt x="611932" y="158011"/>
                  <a:pt x="486442" y="92278"/>
                </a:cubicBezTo>
                <a:cubicBezTo>
                  <a:pt x="462784" y="79886"/>
                  <a:pt x="377606" y="32193"/>
                  <a:pt x="335440" y="25166"/>
                </a:cubicBezTo>
                <a:cubicBezTo>
                  <a:pt x="268726" y="14047"/>
                  <a:pt x="201216" y="8389"/>
                  <a:pt x="134104" y="0"/>
                </a:cubicBezTo>
                <a:cubicBezTo>
                  <a:pt x="106141" y="5593"/>
                  <a:pt x="76056" y="4719"/>
                  <a:pt x="50215" y="16778"/>
                </a:cubicBezTo>
                <a:cubicBezTo>
                  <a:pt x="-53079" y="64982"/>
                  <a:pt x="32062" y="225815"/>
                  <a:pt x="50215" y="285225"/>
                </a:cubicBezTo>
                <a:cubicBezTo>
                  <a:pt x="59054" y="314152"/>
                  <a:pt x="85542" y="334464"/>
                  <a:pt x="100548" y="360726"/>
                </a:cubicBezTo>
                <a:cubicBezTo>
                  <a:pt x="108019" y="373801"/>
                  <a:pt x="110592" y="389202"/>
                  <a:pt x="117326" y="402671"/>
                </a:cubicBezTo>
                <a:cubicBezTo>
                  <a:pt x="135790" y="439600"/>
                  <a:pt x="155045" y="476183"/>
                  <a:pt x="176049" y="511728"/>
                </a:cubicBezTo>
                <a:cubicBezTo>
                  <a:pt x="191437" y="537768"/>
                  <a:pt x="210531" y="561469"/>
                  <a:pt x="226383" y="587229"/>
                </a:cubicBezTo>
                <a:cubicBezTo>
                  <a:pt x="239819" y="609062"/>
                  <a:pt x="250651" y="639509"/>
                  <a:pt x="259939" y="662730"/>
                </a:cubicBezTo>
                <a:cubicBezTo>
                  <a:pt x="257143" y="707471"/>
                  <a:pt x="257890" y="752576"/>
                  <a:pt x="251550" y="796954"/>
                </a:cubicBezTo>
                <a:cubicBezTo>
                  <a:pt x="249420" y="811861"/>
                  <a:pt x="237006" y="824007"/>
                  <a:pt x="234772" y="838899"/>
                </a:cubicBezTo>
                <a:cubicBezTo>
                  <a:pt x="228536" y="880472"/>
                  <a:pt x="229179" y="922788"/>
                  <a:pt x="226383" y="964733"/>
                </a:cubicBezTo>
                <a:cubicBezTo>
                  <a:pt x="229179" y="987104"/>
                  <a:pt x="225324" y="1011375"/>
                  <a:pt x="234772" y="1031845"/>
                </a:cubicBezTo>
                <a:cubicBezTo>
                  <a:pt x="243058" y="1049798"/>
                  <a:pt x="261938" y="1060653"/>
                  <a:pt x="276717" y="1073790"/>
                </a:cubicBezTo>
                <a:cubicBezTo>
                  <a:pt x="317528" y="1110066"/>
                  <a:pt x="363813" y="1128090"/>
                  <a:pt x="419330" y="1140902"/>
                </a:cubicBezTo>
                <a:cubicBezTo>
                  <a:pt x="454856" y="1149100"/>
                  <a:pt x="492035" y="1146495"/>
                  <a:pt x="528387" y="1149291"/>
                </a:cubicBezTo>
                <a:cubicBezTo>
                  <a:pt x="575925" y="1138106"/>
                  <a:pt x="629710" y="1141813"/>
                  <a:pt x="671000" y="1115735"/>
                </a:cubicBezTo>
                <a:cubicBezTo>
                  <a:pt x="690496" y="1103422"/>
                  <a:pt x="681443" y="1070795"/>
                  <a:pt x="687778" y="1048623"/>
                </a:cubicBezTo>
                <a:cubicBezTo>
                  <a:pt x="693371" y="1029049"/>
                  <a:pt x="699200" y="1009540"/>
                  <a:pt x="704556" y="989900"/>
                </a:cubicBezTo>
                <a:cubicBezTo>
                  <a:pt x="707590" y="978777"/>
                  <a:pt x="705915" y="965483"/>
                  <a:pt x="712945" y="956344"/>
                </a:cubicBezTo>
                <a:cubicBezTo>
                  <a:pt x="734646" y="928134"/>
                  <a:pt x="788446" y="880844"/>
                  <a:pt x="788446" y="880844"/>
                </a:cubicBezTo>
                <a:cubicBezTo>
                  <a:pt x="811596" y="695640"/>
                  <a:pt x="802651" y="797733"/>
                  <a:pt x="780057" y="436227"/>
                </a:cubicBezTo>
                <a:cubicBezTo>
                  <a:pt x="779505" y="427401"/>
                  <a:pt x="773995" y="419591"/>
                  <a:pt x="771668" y="411060"/>
                </a:cubicBezTo>
                <a:cubicBezTo>
                  <a:pt x="765601" y="388813"/>
                  <a:pt x="767681" y="363134"/>
                  <a:pt x="754890" y="343948"/>
                </a:cubicBezTo>
                <a:lnTo>
                  <a:pt x="721334" y="293614"/>
                </a:lnTo>
                <a:cubicBezTo>
                  <a:pt x="713724" y="255564"/>
                  <a:pt x="718905" y="253788"/>
                  <a:pt x="696167" y="226502"/>
                </a:cubicBezTo>
                <a:cubicBezTo>
                  <a:pt x="688572" y="217388"/>
                  <a:pt x="680114" y="208930"/>
                  <a:pt x="671000" y="201335"/>
                </a:cubicBezTo>
                <a:cubicBezTo>
                  <a:pt x="663255" y="194880"/>
                  <a:pt x="651426" y="177566"/>
                  <a:pt x="620666" y="159390"/>
                </a:cubicBezTo>
                <a:close/>
              </a:path>
            </a:pathLst>
          </a:cu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CEAB1D2B-ADE1-4B9C-953F-E310F95F40C5}"/>
              </a:ext>
            </a:extLst>
          </p:cNvPr>
          <p:cNvSpPr/>
          <p:nvPr/>
        </p:nvSpPr>
        <p:spPr>
          <a:xfrm rot="19142951">
            <a:off x="10389153" y="1410903"/>
            <a:ext cx="295293" cy="801179"/>
          </a:xfrm>
          <a:prstGeom prst="downArrow">
            <a:avLst/>
          </a:prstGeom>
          <a:solidFill>
            <a:schemeClr val="tx1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7A26522-E420-4972-840F-3B3A626F9D5E}"/>
              </a:ext>
            </a:extLst>
          </p:cNvPr>
          <p:cNvSpPr txBox="1"/>
          <p:nvPr/>
        </p:nvSpPr>
        <p:spPr>
          <a:xfrm>
            <a:off x="8723352" y="502988"/>
            <a:ext cx="800219" cy="369332"/>
          </a:xfrm>
          <a:prstGeom prst="rect">
            <a:avLst/>
          </a:prstGeom>
          <a:solidFill>
            <a:srgbClr val="92D05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txBody>
          <a:bodyPr wrap="none" rtlCol="0">
            <a:spAutoFit/>
          </a:bodyPr>
          <a:lstStyle/>
          <a:p>
            <a:r>
              <a:rPr lang="en-US" dirty="0"/>
              <a:t>Klotho</a:t>
            </a:r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8E266396-D2D0-4163-8741-848724A80B9A}"/>
              </a:ext>
            </a:extLst>
          </p:cNvPr>
          <p:cNvSpPr/>
          <p:nvPr/>
        </p:nvSpPr>
        <p:spPr>
          <a:xfrm>
            <a:off x="10867886" y="1967777"/>
            <a:ext cx="478302" cy="503734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0F110EC-A512-4A55-8A44-74256FC2B06C}"/>
              </a:ext>
            </a:extLst>
          </p:cNvPr>
          <p:cNvSpPr txBox="1"/>
          <p:nvPr/>
        </p:nvSpPr>
        <p:spPr>
          <a:xfrm>
            <a:off x="10839106" y="2010138"/>
            <a:ext cx="578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TH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713F21F-1B4F-4BF4-BBBF-E2E384EC6B3A}"/>
              </a:ext>
            </a:extLst>
          </p:cNvPr>
          <p:cNvSpPr/>
          <p:nvPr/>
        </p:nvSpPr>
        <p:spPr>
          <a:xfrm>
            <a:off x="9600739" y="709312"/>
            <a:ext cx="654341" cy="335316"/>
          </a:xfrm>
          <a:prstGeom prst="rect">
            <a:avLst/>
          </a:prstGeom>
          <a:solidFill>
            <a:srgbClr val="00B0F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CN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BCE721-43BB-4CA6-8486-1E4F3EC98342}"/>
              </a:ext>
            </a:extLst>
          </p:cNvPr>
          <p:cNvSpPr txBox="1"/>
          <p:nvPr/>
        </p:nvSpPr>
        <p:spPr>
          <a:xfrm>
            <a:off x="4927437" y="799100"/>
            <a:ext cx="2095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erphosphatemi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797272F-1371-4A85-AF1C-394458FFF706}"/>
              </a:ext>
            </a:extLst>
          </p:cNvPr>
          <p:cNvSpPr txBox="1"/>
          <p:nvPr/>
        </p:nvSpPr>
        <p:spPr>
          <a:xfrm>
            <a:off x="8648683" y="821825"/>
            <a:ext cx="899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R</a:t>
            </a:r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6E5D2A9C-FDD7-4E59-8C06-1A4313D63350}"/>
              </a:ext>
            </a:extLst>
          </p:cNvPr>
          <p:cNvSpPr/>
          <p:nvPr/>
        </p:nvSpPr>
        <p:spPr>
          <a:xfrm>
            <a:off x="7433298" y="688081"/>
            <a:ext cx="744598" cy="55475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B31D548-313E-4A2B-A96E-8238FEC6274D}"/>
              </a:ext>
            </a:extLst>
          </p:cNvPr>
          <p:cNvSpPr txBox="1"/>
          <p:nvPr/>
        </p:nvSpPr>
        <p:spPr>
          <a:xfrm>
            <a:off x="7375544" y="777295"/>
            <a:ext cx="774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B30F6A2-4145-4C15-8598-F968E2AB9B04}"/>
              </a:ext>
            </a:extLst>
          </p:cNvPr>
          <p:cNvSpPr txBox="1"/>
          <p:nvPr/>
        </p:nvSpPr>
        <p:spPr>
          <a:xfrm>
            <a:off x="10389185" y="692730"/>
            <a:ext cx="753732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MAPK</a:t>
            </a:r>
          </a:p>
        </p:txBody>
      </p:sp>
      <p:sp>
        <p:nvSpPr>
          <p:cNvPr id="32" name="Arrow: Right 31">
            <a:extLst>
              <a:ext uri="{FF2B5EF4-FFF2-40B4-BE49-F238E27FC236}">
                <a16:creationId xmlns:a16="http://schemas.microsoft.com/office/drawing/2014/main" id="{60434CC4-A210-4E8B-B1AE-62DC5163D6FA}"/>
              </a:ext>
            </a:extLst>
          </p:cNvPr>
          <p:cNvSpPr/>
          <p:nvPr/>
        </p:nvSpPr>
        <p:spPr>
          <a:xfrm rot="21081005">
            <a:off x="4435097" y="4730942"/>
            <a:ext cx="361563" cy="131371"/>
          </a:xfrm>
          <a:prstGeom prst="right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Arrow: Right 32">
            <a:extLst>
              <a:ext uri="{FF2B5EF4-FFF2-40B4-BE49-F238E27FC236}">
                <a16:creationId xmlns:a16="http://schemas.microsoft.com/office/drawing/2014/main" id="{1D1E1493-FF34-4BD9-B6B9-6DCBE382C021}"/>
              </a:ext>
            </a:extLst>
          </p:cNvPr>
          <p:cNvSpPr/>
          <p:nvPr/>
        </p:nvSpPr>
        <p:spPr>
          <a:xfrm rot="5400000">
            <a:off x="8429293" y="5133001"/>
            <a:ext cx="793682" cy="215449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C8BAA28-275F-4F27-BA17-041DC1215DE3}"/>
              </a:ext>
            </a:extLst>
          </p:cNvPr>
          <p:cNvSpPr txBox="1"/>
          <p:nvPr/>
        </p:nvSpPr>
        <p:spPr>
          <a:xfrm>
            <a:off x="7565553" y="5713470"/>
            <a:ext cx="312720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/>
              <a:t>Decreases 1-alpha-hydroxylase </a:t>
            </a:r>
          </a:p>
          <a:p>
            <a:r>
              <a:rPr lang="en-US" dirty="0"/>
              <a:t>Increases 24-alpha-hydroxylase</a:t>
            </a:r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A2CC4E8D-EADA-45E4-A0B1-9190B0B29547}"/>
              </a:ext>
            </a:extLst>
          </p:cNvPr>
          <p:cNvSpPr/>
          <p:nvPr/>
        </p:nvSpPr>
        <p:spPr>
          <a:xfrm>
            <a:off x="8491408" y="4311185"/>
            <a:ext cx="744598" cy="554751"/>
          </a:xfrm>
          <a:prstGeom prst="ellipse">
            <a:avLst/>
          </a:prstGeom>
          <a:solidFill>
            <a:srgbClr val="00B050"/>
          </a:solidFill>
          <a:ln>
            <a:noFill/>
          </a:ln>
          <a:effectLst>
            <a:outerShdw blurRad="149987" dist="250190" dir="8460000" algn="ctr">
              <a:srgbClr val="000000">
                <a:alpha val="28000"/>
              </a:srgb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8C1D592-051E-4662-8ED0-08C0D4F2AF39}"/>
              </a:ext>
            </a:extLst>
          </p:cNvPr>
          <p:cNvSpPr txBox="1"/>
          <p:nvPr/>
        </p:nvSpPr>
        <p:spPr>
          <a:xfrm>
            <a:off x="8441379" y="4377989"/>
            <a:ext cx="774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GF23</a:t>
            </a:r>
          </a:p>
        </p:txBody>
      </p:sp>
      <p:sp>
        <p:nvSpPr>
          <p:cNvPr id="85" name="Arrow: Right 84">
            <a:extLst>
              <a:ext uri="{FF2B5EF4-FFF2-40B4-BE49-F238E27FC236}">
                <a16:creationId xmlns:a16="http://schemas.microsoft.com/office/drawing/2014/main" id="{869DFB6C-3766-4801-929A-14DDAA2837F4}"/>
              </a:ext>
            </a:extLst>
          </p:cNvPr>
          <p:cNvSpPr/>
          <p:nvPr/>
        </p:nvSpPr>
        <p:spPr>
          <a:xfrm rot="10800000">
            <a:off x="6703193" y="5931554"/>
            <a:ext cx="793682" cy="21544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885C46F-7142-4D10-B49A-58374D8983B0}"/>
              </a:ext>
            </a:extLst>
          </p:cNvPr>
          <p:cNvSpPr txBox="1"/>
          <p:nvPr/>
        </p:nvSpPr>
        <p:spPr>
          <a:xfrm>
            <a:off x="5631978" y="5603538"/>
            <a:ext cx="105032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/>
              <a:t>1,25 Vitamin D (D3)</a:t>
            </a:r>
          </a:p>
        </p:txBody>
      </p:sp>
    </p:spTree>
    <p:extLst>
      <p:ext uri="{BB962C8B-B14F-4D97-AF65-F5344CB8AC3E}">
        <p14:creationId xmlns:p14="http://schemas.microsoft.com/office/powerpoint/2010/main" val="2389079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y Hanna</dc:creator>
  <cp:lastModifiedBy>Michael Cunningham</cp:lastModifiedBy>
  <cp:revision>21</cp:revision>
  <dcterms:created xsi:type="dcterms:W3CDTF">2021-05-04T04:42:36Z</dcterms:created>
  <dcterms:modified xsi:type="dcterms:W3CDTF">2022-02-24T13:25:07Z</dcterms:modified>
</cp:coreProperties>
</file>